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6" d="100"/>
          <a:sy n="46" d="100"/>
        </p:scale>
        <p:origin x="2837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876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2891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035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372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4053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992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3941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463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977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859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9968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7160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6545FF72-957C-4380-8980-3FA1097856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191868"/>
            <a:ext cx="103939" cy="2078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51435" tIns="25718" rIns="51435" bIns="25718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 sz="1013"/>
          </a:p>
        </p:txBody>
      </p:sp>
      <p:pic>
        <p:nvPicPr>
          <p:cNvPr id="2052" name="Picture 644">
            <a:extLst>
              <a:ext uri="{FF2B5EF4-FFF2-40B4-BE49-F238E27FC236}">
                <a16:creationId xmlns:a16="http://schemas.microsoft.com/office/drawing/2014/main" id="{E8F676AE-9F9F-4DFC-A56E-909F1E56460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9119" y="0"/>
            <a:ext cx="4779761" cy="27833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A09ABA79-7D4B-4830-9FAE-C611C04B22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" y="2754516"/>
            <a:ext cx="6858000" cy="4212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51435" tIns="25718" rIns="51435" bIns="25718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5143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u-HU" altLang="en-US" sz="1200" b="1" dirty="0">
                <a:latin typeface="Segoe UI" panose="020B0502040204020203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Figure S3.</a:t>
            </a:r>
            <a:r>
              <a:rPr lang="hu-HU" altLang="en-US" sz="1200" dirty="0">
                <a:latin typeface="Segoe UI" panose="020B0502040204020203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 Images of whole plant phenotype in </a:t>
            </a:r>
            <a:r>
              <a:rPr lang="hu-HU" altLang="en-US" sz="1200" i="1" dirty="0">
                <a:latin typeface="Segoe UI" panose="020B0502040204020203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cslf6-2 </a:t>
            </a:r>
            <a:r>
              <a:rPr lang="hu-HU" altLang="en-US" sz="1200" dirty="0">
                <a:latin typeface="Segoe UI" panose="020B0502040204020203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homozygous line (left), compared to WT (right) at 10 and 15 weeks old. Images were taken in the glasshouse between April and May 2017. </a:t>
            </a:r>
            <a:endParaRPr lang="hu-HU" altLang="en-US" sz="28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2898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4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egoe U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illermo Garcia</dc:creator>
  <cp:lastModifiedBy>Guillermo Garcia</cp:lastModifiedBy>
  <cp:revision>9</cp:revision>
  <dcterms:created xsi:type="dcterms:W3CDTF">2020-05-14T00:51:09Z</dcterms:created>
  <dcterms:modified xsi:type="dcterms:W3CDTF">2020-05-14T01:33:17Z</dcterms:modified>
</cp:coreProperties>
</file>